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0" autoAdjust="0"/>
    <p:restoredTop sz="94660"/>
  </p:normalViewPr>
  <p:slideViewPr>
    <p:cSldViewPr snapToGrid="0">
      <p:cViewPr varScale="1">
        <p:scale>
          <a:sx n="74" d="100"/>
          <a:sy n="74" d="100"/>
        </p:scale>
        <p:origin x="18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3FF38-E4FA-4C18-AA93-AC19309D7A3D}" type="datetimeFigureOut">
              <a:rPr lang="en-IN" smtClean="0"/>
              <a:t>19-01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F3C70-E1DF-431E-8E6F-1CBFAFD1B8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223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3FF38-E4FA-4C18-AA93-AC19309D7A3D}" type="datetimeFigureOut">
              <a:rPr lang="en-IN" smtClean="0"/>
              <a:t>19-01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F3C70-E1DF-431E-8E6F-1CBFAFD1B8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15872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3FF38-E4FA-4C18-AA93-AC19309D7A3D}" type="datetimeFigureOut">
              <a:rPr lang="en-IN" smtClean="0"/>
              <a:t>19-01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F3C70-E1DF-431E-8E6F-1CBFAFD1B8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94110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3FF38-E4FA-4C18-AA93-AC19309D7A3D}" type="datetimeFigureOut">
              <a:rPr lang="en-IN" smtClean="0"/>
              <a:t>19-01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F3C70-E1DF-431E-8E6F-1CBFAFD1B8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767549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3FF38-E4FA-4C18-AA93-AC19309D7A3D}" type="datetimeFigureOut">
              <a:rPr lang="en-IN" smtClean="0"/>
              <a:t>19-01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F3C70-E1DF-431E-8E6F-1CBFAFD1B8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415776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3FF38-E4FA-4C18-AA93-AC19309D7A3D}" type="datetimeFigureOut">
              <a:rPr lang="en-IN" smtClean="0"/>
              <a:t>19-01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F3C70-E1DF-431E-8E6F-1CBFAFD1B8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63234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3FF38-E4FA-4C18-AA93-AC19309D7A3D}" type="datetimeFigureOut">
              <a:rPr lang="en-IN" smtClean="0"/>
              <a:t>19-01-20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F3C70-E1DF-431E-8E6F-1CBFAFD1B8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912901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3FF38-E4FA-4C18-AA93-AC19309D7A3D}" type="datetimeFigureOut">
              <a:rPr lang="en-IN" smtClean="0"/>
              <a:t>19-01-20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F3C70-E1DF-431E-8E6F-1CBFAFD1B8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225447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3FF38-E4FA-4C18-AA93-AC19309D7A3D}" type="datetimeFigureOut">
              <a:rPr lang="en-IN" smtClean="0"/>
              <a:t>19-01-20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F3C70-E1DF-431E-8E6F-1CBFAFD1B8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48603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3FF38-E4FA-4C18-AA93-AC19309D7A3D}" type="datetimeFigureOut">
              <a:rPr lang="en-IN" smtClean="0"/>
              <a:t>19-01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F3C70-E1DF-431E-8E6F-1CBFAFD1B8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84885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63FF38-E4FA-4C18-AA93-AC19309D7A3D}" type="datetimeFigureOut">
              <a:rPr lang="en-IN" smtClean="0"/>
              <a:t>19-01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F3C70-E1DF-431E-8E6F-1CBFAFD1B8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40850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63FF38-E4FA-4C18-AA93-AC19309D7A3D}" type="datetimeFigureOut">
              <a:rPr lang="en-IN" smtClean="0"/>
              <a:t>19-01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DF3C70-E1DF-431E-8E6F-1CBFAFD1B88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817803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JPG"/><Relationship Id="rId4" Type="http://schemas.openxmlformats.org/officeDocument/2006/relationships/image" Target="../media/image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1427" y="1366140"/>
            <a:ext cx="4088193" cy="423535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65034" y="1333903"/>
            <a:ext cx="3001993" cy="423535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536830" y="5572664"/>
            <a:ext cx="12853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8140460" y="5572664"/>
            <a:ext cx="12853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953000" y="2064105"/>
            <a:ext cx="14012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dirty="0"/>
              <a:t>GIV (Cosmopolitan)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842778" y="4554871"/>
            <a:ext cx="14012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dirty="0"/>
              <a:t>GIII (American/Asian)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909620" y="2860876"/>
            <a:ext cx="12234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dirty="0"/>
              <a:t>GV(American)</a:t>
            </a:r>
          </a:p>
        </p:txBody>
      </p:sp>
      <p:sp>
        <p:nvSpPr>
          <p:cNvPr id="13" name="Right Brace 12"/>
          <p:cNvSpPr/>
          <p:nvPr/>
        </p:nvSpPr>
        <p:spPr>
          <a:xfrm>
            <a:off x="4705918" y="2750743"/>
            <a:ext cx="69521" cy="500127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4" name="Right Brace 13"/>
          <p:cNvSpPr/>
          <p:nvPr/>
        </p:nvSpPr>
        <p:spPr>
          <a:xfrm>
            <a:off x="4634666" y="4470965"/>
            <a:ext cx="71252" cy="444318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5" name="Right Brace 14"/>
          <p:cNvSpPr/>
          <p:nvPr/>
        </p:nvSpPr>
        <p:spPr>
          <a:xfrm>
            <a:off x="4838790" y="1447428"/>
            <a:ext cx="61954" cy="1196486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16" name="TextBox 15"/>
          <p:cNvSpPr txBox="1"/>
          <p:nvPr/>
        </p:nvSpPr>
        <p:spPr>
          <a:xfrm>
            <a:off x="4269154" y="3309880"/>
            <a:ext cx="14012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dirty="0"/>
              <a:t>Sylvatic strain 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568073" y="3646642"/>
            <a:ext cx="12234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dirty="0"/>
              <a:t>GII(Asian II)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765343" y="4095646"/>
            <a:ext cx="12234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dirty="0"/>
              <a:t>GI(Asian I)</a:t>
            </a:r>
          </a:p>
        </p:txBody>
      </p:sp>
      <p:sp>
        <p:nvSpPr>
          <p:cNvPr id="19" name="Right Brace 18"/>
          <p:cNvSpPr/>
          <p:nvPr/>
        </p:nvSpPr>
        <p:spPr>
          <a:xfrm>
            <a:off x="4474001" y="3603794"/>
            <a:ext cx="94072" cy="324776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0" name="Right Brace 19"/>
          <p:cNvSpPr/>
          <p:nvPr/>
        </p:nvSpPr>
        <p:spPr>
          <a:xfrm>
            <a:off x="4606383" y="4027792"/>
            <a:ext cx="112291" cy="397319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1" name="5-Point Star 20"/>
          <p:cNvSpPr/>
          <p:nvPr/>
        </p:nvSpPr>
        <p:spPr>
          <a:xfrm>
            <a:off x="4406319" y="2257255"/>
            <a:ext cx="45719" cy="110795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2" name="Oval 21"/>
          <p:cNvSpPr/>
          <p:nvPr/>
        </p:nvSpPr>
        <p:spPr>
          <a:xfrm>
            <a:off x="4386001" y="2135781"/>
            <a:ext cx="45719" cy="61535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3" name="Right Brace 22"/>
          <p:cNvSpPr/>
          <p:nvPr/>
        </p:nvSpPr>
        <p:spPr>
          <a:xfrm>
            <a:off x="10172265" y="4391080"/>
            <a:ext cx="77255" cy="773587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4" name="Right Brace 23"/>
          <p:cNvSpPr/>
          <p:nvPr/>
        </p:nvSpPr>
        <p:spPr>
          <a:xfrm>
            <a:off x="10172302" y="3539208"/>
            <a:ext cx="45719" cy="649551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5" name="Right Brace 24"/>
          <p:cNvSpPr/>
          <p:nvPr/>
        </p:nvSpPr>
        <p:spPr>
          <a:xfrm>
            <a:off x="10119182" y="1389916"/>
            <a:ext cx="86020" cy="2039083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26" name="TextBox 25"/>
          <p:cNvSpPr txBox="1"/>
          <p:nvPr/>
        </p:nvSpPr>
        <p:spPr>
          <a:xfrm>
            <a:off x="10302145" y="4689523"/>
            <a:ext cx="70204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dirty="0"/>
              <a:t>GII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0392478" y="3733178"/>
            <a:ext cx="12234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dirty="0"/>
              <a:t>GI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0311875" y="2437038"/>
            <a:ext cx="12234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dirty="0"/>
              <a:t>GIII</a:t>
            </a:r>
          </a:p>
        </p:txBody>
      </p:sp>
      <p:sp>
        <p:nvSpPr>
          <p:cNvPr id="29" name="5-Point Star 28"/>
          <p:cNvSpPr/>
          <p:nvPr/>
        </p:nvSpPr>
        <p:spPr>
          <a:xfrm>
            <a:off x="9841339" y="1783122"/>
            <a:ext cx="45719" cy="110795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0" name="Oval 29"/>
          <p:cNvSpPr/>
          <p:nvPr/>
        </p:nvSpPr>
        <p:spPr>
          <a:xfrm>
            <a:off x="9810280" y="1482433"/>
            <a:ext cx="45719" cy="61535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1" name="Oval 30"/>
          <p:cNvSpPr/>
          <p:nvPr/>
        </p:nvSpPr>
        <p:spPr>
          <a:xfrm>
            <a:off x="9824529" y="1647567"/>
            <a:ext cx="45719" cy="61535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8" name="Rectangle 5"/>
          <p:cNvSpPr>
            <a:spLocks noChangeArrowheads="1"/>
          </p:cNvSpPr>
          <p:nvPr/>
        </p:nvSpPr>
        <p:spPr bwMode="auto">
          <a:xfrm>
            <a:off x="1301725" y="387344"/>
            <a:ext cx="9351444" cy="12464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1: </a:t>
            </a:r>
            <a:r>
              <a:rPr lang="en-US" sz="1200" b="1" dirty="0" smtClean="0">
                <a:latin typeface="Palatino Linotype" panose="02040502050505030304" pitchFamily="18" charset="0"/>
              </a:rPr>
              <a:t>Supplementary Figure S1: </a:t>
            </a:r>
            <a:r>
              <a:rPr lang="en-US" sz="1200" dirty="0" smtClean="0">
                <a:latin typeface="Palatino Linotype" panose="02040502050505030304" pitchFamily="18" charset="0"/>
              </a:rPr>
              <a:t>Molecular phylogenetic tree (a) DENV-2 (b) DENV-3 based on </a:t>
            </a:r>
            <a:r>
              <a:rPr lang="en-US" sz="1200" dirty="0" err="1" smtClean="0">
                <a:latin typeface="Palatino Linotype" panose="02040502050505030304" pitchFamily="18" charset="0"/>
              </a:rPr>
              <a:t>CpRM</a:t>
            </a:r>
            <a:r>
              <a:rPr lang="en-US" sz="1200" dirty="0" smtClean="0">
                <a:latin typeface="Palatino Linotype" panose="02040502050505030304" pitchFamily="18" charset="0"/>
              </a:rPr>
              <a:t> sequence generated as described in methods. The present study sequences are marked by the    symbol which clustered in GIV for DENV-2 and GIII for DENV-3.   indicates previously identified from our lab.</a:t>
            </a:r>
          </a:p>
          <a:p>
            <a:endParaRPr lang="en-IN" dirty="0"/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0" lang="en-US" alt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Palatino Linotype" panose="0204050205050503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Palatino Linotype" panose="02040502050505030304" pitchFamily="18" charset="0"/>
            </a:endParaRPr>
          </a:p>
        </p:txBody>
      </p:sp>
      <p:sp>
        <p:nvSpPr>
          <p:cNvPr id="32" name="5-Point Star 31"/>
          <p:cNvSpPr/>
          <p:nvPr/>
        </p:nvSpPr>
        <p:spPr>
          <a:xfrm>
            <a:off x="7060383" y="649873"/>
            <a:ext cx="45719" cy="110795"/>
          </a:xfrm>
          <a:prstGeom prst="star5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sp>
        <p:nvSpPr>
          <p:cNvPr id="33" name="Oval 32"/>
          <p:cNvSpPr/>
          <p:nvPr/>
        </p:nvSpPr>
        <p:spPr>
          <a:xfrm>
            <a:off x="2580213" y="864820"/>
            <a:ext cx="45719" cy="61535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862440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153931" y="4351393"/>
            <a:ext cx="12853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0678" y="1304086"/>
            <a:ext cx="2765356" cy="438934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5744" y="1304087"/>
            <a:ext cx="2621636" cy="4453243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8485796" y="6143804"/>
            <a:ext cx="12853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1" b="2229"/>
          <a:stretch/>
        </p:blipFill>
        <p:spPr>
          <a:xfrm>
            <a:off x="9056329" y="1064594"/>
            <a:ext cx="2617711" cy="5258568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6752255" y="4459045"/>
            <a:ext cx="48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3’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7190062" y="3794895"/>
            <a:ext cx="48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40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8409110" y="5084046"/>
            <a:ext cx="48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280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8341422" y="1481429"/>
            <a:ext cx="48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16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7901852" y="1189722"/>
            <a:ext cx="48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120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7520076" y="2443619"/>
            <a:ext cx="48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80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7889680" y="3049256"/>
            <a:ext cx="48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200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6317477" y="4470586"/>
            <a:ext cx="48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360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7661005" y="4881740"/>
            <a:ext cx="48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240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6552631" y="5194657"/>
            <a:ext cx="48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320</a:t>
            </a:r>
          </a:p>
        </p:txBody>
      </p:sp>
      <p:sp>
        <p:nvSpPr>
          <p:cNvPr id="24" name="Rectangle 23"/>
          <p:cNvSpPr/>
          <p:nvPr/>
        </p:nvSpPr>
        <p:spPr>
          <a:xfrm>
            <a:off x="6694997" y="4267724"/>
            <a:ext cx="30328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100" dirty="0"/>
              <a:t>5</a:t>
            </a:r>
            <a:r>
              <a:rPr lang="en-IN" sz="1200" b="1" dirty="0"/>
              <a:t>’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9793753" y="4881740"/>
            <a:ext cx="48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3’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702957" y="4689947"/>
            <a:ext cx="48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5’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1334691" y="5713144"/>
            <a:ext cx="894714" cy="2526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280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1163512" y="4779711"/>
            <a:ext cx="48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24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10972879" y="6105860"/>
            <a:ext cx="48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32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9390771" y="5720683"/>
            <a:ext cx="48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4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10225050" y="4003681"/>
            <a:ext cx="48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40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11192347" y="1451332"/>
            <a:ext cx="48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16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10706744" y="1105377"/>
            <a:ext cx="48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120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10465897" y="2451985"/>
            <a:ext cx="48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80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10922665" y="3320628"/>
            <a:ext cx="48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200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10365184" y="4689947"/>
            <a:ext cx="48275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360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9387381" y="4953241"/>
            <a:ext cx="4816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50" b="1" dirty="0"/>
              <a:t>450</a:t>
            </a:r>
          </a:p>
        </p:txBody>
      </p:sp>
      <p:sp>
        <p:nvSpPr>
          <p:cNvPr id="38" name="TextBox 3">
            <a:extLst>
              <a:ext uri="{FF2B5EF4-FFF2-40B4-BE49-F238E27FC236}">
                <a16:creationId xmlns:a16="http://schemas.microsoft.com/office/drawing/2014/main" id="{02086EF6-6982-41F1-8EC3-CEEC3D7E38BC}"/>
              </a:ext>
            </a:extLst>
          </p:cNvPr>
          <p:cNvSpPr txBox="1"/>
          <p:nvPr/>
        </p:nvSpPr>
        <p:spPr>
          <a:xfrm>
            <a:off x="214283" y="2604749"/>
            <a:ext cx="5187688" cy="141577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IN" sz="700" b="1" dirty="0">
                <a:latin typeface="Courier New" panose="02070309020205020404" pitchFamily="49" charset="0"/>
                <a:cs typeface="Courier New" panose="02070309020205020404" pitchFamily="49" charset="0"/>
              </a:rPr>
              <a:t>KU551903/INDIA/2014</a:t>
            </a:r>
          </a:p>
          <a:p>
            <a:r>
              <a:rPr lang="en-IN" sz="700" b="1" dirty="0">
                <a:latin typeface="Courier New" panose="02070309020205020404" pitchFamily="49" charset="0"/>
                <a:cs typeface="Courier New" panose="02070309020205020404" pitchFamily="49" charset="0"/>
              </a:rPr>
              <a:t>KT282380/INDIA/2014</a:t>
            </a:r>
          </a:p>
          <a:p>
            <a:r>
              <a:rPr lang="en-IN" sz="700" b="1" dirty="0">
                <a:latin typeface="Courier New" panose="02070309020205020404" pitchFamily="49" charset="0"/>
                <a:cs typeface="Courier New" panose="02070309020205020404" pitchFamily="49" charset="0"/>
              </a:rPr>
              <a:t>KT186254/SINGAPORE/2013</a:t>
            </a:r>
          </a:p>
          <a:p>
            <a:r>
              <a:rPr lang="en-IN" sz="700" b="1" dirty="0">
                <a:latin typeface="Courier New" panose="02070309020205020404" pitchFamily="49" charset="0"/>
                <a:cs typeface="Courier New" panose="02070309020205020404" pitchFamily="49" charset="0"/>
              </a:rPr>
              <a:t>KY923048/MALAYSIA/2018</a:t>
            </a:r>
          </a:p>
          <a:p>
            <a:r>
              <a:rPr lang="en-IN" sz="700" b="1" dirty="0">
                <a:latin typeface="Courier New" panose="02070309020205020404" pitchFamily="49" charset="0"/>
                <a:cs typeface="Courier New" panose="02070309020205020404" pitchFamily="49" charset="0"/>
              </a:rPr>
              <a:t>MG560143/HYDERABAD INDIA/2014 </a:t>
            </a:r>
          </a:p>
          <a:p>
            <a:r>
              <a:rPr lang="en-IN" sz="700" b="1" dirty="0">
                <a:latin typeface="Courier New" panose="02070309020205020404" pitchFamily="49" charset="0"/>
                <a:cs typeface="Courier New" panose="02070309020205020404" pitchFamily="49" charset="0"/>
              </a:rPr>
              <a:t>KT186254/SINGAPORE/2013</a:t>
            </a:r>
          </a:p>
          <a:p>
            <a:r>
              <a:rPr lang="en-IN" sz="700" b="1" dirty="0">
                <a:latin typeface="Courier New" panose="02070309020205020404" pitchFamily="49" charset="0"/>
                <a:cs typeface="Courier New" panose="02070309020205020404" pitchFamily="49" charset="0"/>
              </a:rPr>
              <a:t>MF459663/CHINA/2013</a:t>
            </a:r>
          </a:p>
          <a:p>
            <a:r>
              <a:rPr lang="en-IN" sz="700" b="1" dirty="0">
                <a:latin typeface="Courier New" panose="02070309020205020404" pitchFamily="49" charset="0"/>
                <a:cs typeface="Courier New" panose="02070309020205020404" pitchFamily="49" charset="0"/>
              </a:rPr>
              <a:t>KY882458/CHINA/2017</a:t>
            </a:r>
          </a:p>
          <a:p>
            <a:r>
              <a:rPr lang="en-IN" sz="700" b="1" dirty="0">
                <a:latin typeface="Courier New" panose="02070309020205020404" pitchFamily="49" charset="0"/>
                <a:cs typeface="Courier New" panose="02070309020205020404" pitchFamily="49" charset="0"/>
              </a:rPr>
              <a:t>GQ868625/CAMBODIA/2009</a:t>
            </a:r>
          </a:p>
          <a:p>
            <a:r>
              <a:rPr lang="en-IN" sz="700" b="1">
                <a:latin typeface="Courier New" panose="02070309020205020404" pitchFamily="49" charset="0"/>
                <a:cs typeface="Courier New" panose="02070309020205020404" pitchFamily="49" charset="0"/>
              </a:rPr>
              <a:t>MG560144/HYDERABAD INDIA/2014</a:t>
            </a:r>
            <a:endParaRPr lang="en-IN" sz="7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IN" sz="700" b="1" dirty="0">
                <a:latin typeface="Courier New" panose="02070309020205020404" pitchFamily="49" charset="0"/>
                <a:cs typeface="Courier New" panose="02070309020205020404" pitchFamily="49" charset="0"/>
              </a:rPr>
              <a:t>JX475906/INDIA/2014</a:t>
            </a:r>
          </a:p>
          <a:p>
            <a:r>
              <a:rPr lang="en-IN" sz="700" b="1" dirty="0">
                <a:latin typeface="Courier New" panose="02070309020205020404" pitchFamily="49" charset="0"/>
                <a:cs typeface="Courier New" panose="02070309020205020404" pitchFamily="49" charset="0"/>
              </a:rPr>
              <a:t>DQ448231/GWL/INDIA/2001</a:t>
            </a:r>
          </a:p>
        </p:txBody>
      </p:sp>
      <p:sp>
        <p:nvSpPr>
          <p:cNvPr id="39" name="Right Brace 38">
            <a:extLst>
              <a:ext uri="{FF2B5EF4-FFF2-40B4-BE49-F238E27FC236}">
                <a16:creationId xmlns:a16="http://schemas.microsoft.com/office/drawing/2014/main" id="{16DD8ABE-5B88-4F8B-A547-44BD656D1121}"/>
              </a:ext>
            </a:extLst>
          </p:cNvPr>
          <p:cNvSpPr/>
          <p:nvPr/>
        </p:nvSpPr>
        <p:spPr>
          <a:xfrm rot="16200000">
            <a:off x="3625582" y="179185"/>
            <a:ext cx="365139" cy="3797101"/>
          </a:xfrm>
          <a:prstGeom prst="rightBrace">
            <a:avLst>
              <a:gd name="adj1" fmla="val 0"/>
              <a:gd name="adj2" fmla="val 49831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IN" dirty="0"/>
          </a:p>
        </p:txBody>
      </p:sp>
      <p:sp>
        <p:nvSpPr>
          <p:cNvPr id="40" name="TextBox 5">
            <a:extLst>
              <a:ext uri="{FF2B5EF4-FFF2-40B4-BE49-F238E27FC236}">
                <a16:creationId xmlns:a16="http://schemas.microsoft.com/office/drawing/2014/main" id="{162BF4E7-7ABA-497C-A3C4-08614F2AA309}"/>
              </a:ext>
            </a:extLst>
          </p:cNvPr>
          <p:cNvSpPr txBox="1"/>
          <p:nvPr/>
        </p:nvSpPr>
        <p:spPr>
          <a:xfrm>
            <a:off x="3005514" y="1625286"/>
            <a:ext cx="36921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IN" sz="1200" dirty="0"/>
              <a:t>Stem Loop region (SL)</a:t>
            </a:r>
          </a:p>
        </p:txBody>
      </p:sp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8" r="42"/>
          <a:stretch/>
        </p:blipFill>
        <p:spPr>
          <a:xfrm>
            <a:off x="1879769" y="2388530"/>
            <a:ext cx="3894668" cy="1608683"/>
          </a:xfrm>
          <a:prstGeom prst="rect">
            <a:avLst/>
          </a:prstGeom>
        </p:spPr>
      </p:pic>
      <p:sp>
        <p:nvSpPr>
          <p:cNvPr id="42" name="Oval 41"/>
          <p:cNvSpPr/>
          <p:nvPr/>
        </p:nvSpPr>
        <p:spPr>
          <a:xfrm>
            <a:off x="218885" y="3093155"/>
            <a:ext cx="59266" cy="902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IN"/>
          </a:p>
        </p:txBody>
      </p:sp>
      <p:sp>
        <p:nvSpPr>
          <p:cNvPr id="43" name="Oval 42"/>
          <p:cNvSpPr/>
          <p:nvPr/>
        </p:nvSpPr>
        <p:spPr>
          <a:xfrm>
            <a:off x="222959" y="3615120"/>
            <a:ext cx="59266" cy="902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IN"/>
          </a:p>
        </p:txBody>
      </p:sp>
      <p:sp>
        <p:nvSpPr>
          <p:cNvPr id="4" name="Rectangle 3"/>
          <p:cNvSpPr/>
          <p:nvPr/>
        </p:nvSpPr>
        <p:spPr>
          <a:xfrm>
            <a:off x="1004347" y="384940"/>
            <a:ext cx="999300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Supplementary Figure S2: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 (a) Comparative nucleotide sequence alignment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</a:rPr>
              <a:t>using </a:t>
            </a:r>
            <a:r>
              <a:rPr lang="en-US" sz="1200" smtClean="0">
                <a:solidFill>
                  <a:srgbClr val="000000"/>
                </a:solidFill>
                <a:latin typeface="Times New Roman" panose="02020603050405020304" pitchFamily="18" charset="0"/>
              </a:rPr>
              <a:t>DENV-2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3’UTR sequences obtained from NCBI database and the sequence identified previously in our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lab    (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b) Predicted RNA secondary structure of the full length and mutant DENV-2 3’UTR using the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UNAfold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 webserver.</a:t>
            </a:r>
          </a:p>
        </p:txBody>
      </p:sp>
      <p:sp>
        <p:nvSpPr>
          <p:cNvPr id="9" name="Oval 8"/>
          <p:cNvSpPr/>
          <p:nvPr/>
        </p:nvSpPr>
        <p:spPr>
          <a:xfrm>
            <a:off x="3022766" y="676636"/>
            <a:ext cx="74116" cy="73210"/>
          </a:xfrm>
          <a:prstGeom prst="ellipse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263435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185</Words>
  <Application>Microsoft Office PowerPoint</Application>
  <PresentationFormat>Widescreen</PresentationFormat>
  <Paragraphs>5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rial</vt:lpstr>
      <vt:lpstr>Calibri</vt:lpstr>
      <vt:lpstr>Calibri Light</vt:lpstr>
      <vt:lpstr>Courier New</vt:lpstr>
      <vt:lpstr>Palatino Linotype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eptimais@outlook.com</dc:creator>
  <cp:lastModifiedBy>deeptimais@outlook.com</cp:lastModifiedBy>
  <cp:revision>21</cp:revision>
  <dcterms:created xsi:type="dcterms:W3CDTF">2022-08-25T14:02:28Z</dcterms:created>
  <dcterms:modified xsi:type="dcterms:W3CDTF">2023-01-19T06:45:10Z</dcterms:modified>
</cp:coreProperties>
</file>